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3" r:id="rId3"/>
    <p:sldId id="264" r:id="rId4"/>
    <p:sldId id="259" r:id="rId5"/>
    <p:sldId id="260" r:id="rId6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>
        <p:scale>
          <a:sx n="70" d="100"/>
          <a:sy n="70" d="100"/>
        </p:scale>
        <p:origin x="618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7F6DAC4-25EB-4216-B48C-4C0DEE822E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7A2C710-0A90-4F1D-B894-B4904D5FF6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9F16AFE-3221-4C75-A880-0AEDEA581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9AAAA31-FD3E-4217-AAF9-2E075A5FA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47EC0C0-A1A5-4FC3-A1F4-DA7EFA795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948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B176152-A369-45C6-8AEB-6350E7329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0AEC59E-1CAD-4B11-841A-4BBBCB81AD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3F54F96-D214-4AEF-A256-AD53B4D4A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E7CD068-6A32-4399-99CE-A1F903EE9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33DC241-E3E2-4170-98E8-33803B22D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48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9C33418-B5BB-42C2-904E-9838760E40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96128AD-B189-45E2-A10A-E20C0F9AD1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1259D1E-04E0-44B0-9D0F-E98A678DD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3E2A088-9E36-4D28-91E2-32CA3382C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1C9A43A-D25C-4EFF-9373-D12EE134B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127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8FE3BD-AB5D-4CD4-8097-2F5A1F4B4A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4A701AA-2067-408C-9B6A-71A7838A99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3508641-CE3F-493D-B4B0-3C9883CB7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2CCDB43-B472-4973-B17E-3B55BC646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D49AE0A-5937-44D8-9949-DF0AC4833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5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17893F-5842-4D30-9F20-F3599F3E9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6D0D520-18C3-43FD-B9B6-180EF5C30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B54F37A-1FB1-444F-BB82-98364D31C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D724D2B-FCA7-4596-BE0A-A03ECABAF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5DC051-888B-4FDF-A6FD-CBF4F7401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838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9CD8490-5529-4D02-853B-058CE49716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3AFFDD5-6BCA-447C-A524-FF0AD7842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7CCC4A8-32FE-4946-8AEA-225521B23B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320F6F9-27D4-4E78-9F6A-070576561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D693D62-235C-4A35-920E-1AD4D2518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C618E1A-721D-4687-B3CB-892666120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5411085-FF22-4B6E-98ED-51D1771205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F242DAC-66E8-40F6-9EBB-D47552D66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822224F-0193-4E50-9D2C-8286162AD0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E29F7A8-2359-4D91-BDB6-35EFE90E7C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A0208A67-55EC-45D8-9C09-0F4F9B9C35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366FB02-5DB9-4C8A-9B3D-666230B23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EAC8D69-74CF-4BA8-BBC7-6AAEB01A3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3D2894C-461B-4930-8E70-4207E75BB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390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B6C02EC-4EE4-4C4C-893E-E726F03E0C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B85A027-7E21-40EE-9A45-A1872DA02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59A5C7D-B4CA-4026-A1D5-EDE478C86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2245EBE3-3C68-45EB-A42E-B63625134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198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2A20B8F-17C7-4E15-8329-1D6AC6F13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2FE1605-B405-41C2-9E12-D1E934AC9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C2EE03C-F7F5-41D3-9AFF-E717E6008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891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BD03C9E-1279-4492-BA4D-C5D87C385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3B615A2-F56D-4DD2-85AA-22C308DB23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9E12AA4-F1D1-4360-B9D3-7323CCAC52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BB8F641-A8DB-40A5-8A4A-71985E94E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CE88E3C-B69E-4FAE-B414-670C2E26D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73B845D-E760-480F-8AE9-701DE94FA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633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3914F0F-165C-4BF5-B784-07BD8BB7F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3CE76E8-5D81-4FC8-B9CF-B4142062A8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85FB7C8-D25A-47DB-BE27-466BB37467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F7DC77C-229F-4D3C-A6A5-44B9EC0AE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C25799F-FC58-4310-9EB9-617B685C6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124A2C4-7B61-4132-9E3D-D08638839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218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96C0586-54EC-4B48-8565-44E8FB17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7822EB5-7A6C-463D-9572-46081B798F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840B5EA-0480-48E2-8211-CB8F32ECD7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55344-4E70-43F1-991A-F1DC6FA710D3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92CF06E-2554-4272-BD04-A927F73817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08B9F65-F42D-43FB-B8EF-28401096E5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18001-8D10-4621-8731-B613DEFEC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380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microsoft.com/office/2007/relationships/hdphoto" Target="../media/hdphoto4.wdp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9FD7246A-F1BE-4538-91C7-98A3490E78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2394404"/>
              </p:ext>
            </p:extLst>
          </p:nvPr>
        </p:nvGraphicFramePr>
        <p:xfrm>
          <a:off x="3590989" y="2135134"/>
          <a:ext cx="4914900" cy="291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" name="Prism 7" r:id="rId3" imgW="4915132" imgH="2918328" progId="Prism7.Document">
                  <p:embed/>
                </p:oleObj>
              </mc:Choice>
              <mc:Fallback>
                <p:oleObj name="Prism 7" r:id="rId3" imgW="4915132" imgH="2918328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xmlns="" id="{9FD7246A-F1BE-4538-91C7-98A3490E78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90989" y="2135134"/>
                        <a:ext cx="4914900" cy="2917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18187" y="425002"/>
            <a:ext cx="30909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964835" y="4911291"/>
            <a:ext cx="637234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1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rsinia pesti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M5 and the isogenic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pB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AB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ins were grown overnight in  HIB growth media and next day were diluted and grown for 1 hour at 26 °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constant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king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ter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hour the cultures were shifted to 37°C. At the indicated time points, the OD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determined. </a:t>
            </a:r>
          </a:p>
        </p:txBody>
      </p:sp>
    </p:spTree>
    <p:extLst>
      <p:ext uri="{BB962C8B-B14F-4D97-AF65-F5344CB8AC3E}">
        <p14:creationId xmlns:p14="http://schemas.microsoft.com/office/powerpoint/2010/main" val="2735292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506087" y="905696"/>
            <a:ext cx="2664003" cy="4378845"/>
            <a:chOff x="2875024" y="1145208"/>
            <a:chExt cx="2664003" cy="4378845"/>
          </a:xfrm>
        </p:grpSpPr>
        <p:sp>
          <p:nvSpPr>
            <p:cNvPr id="4" name="TextBox 12">
              <a:extLst>
                <a:ext uri="{FF2B5EF4-FFF2-40B4-BE49-F238E27FC236}">
                  <a16:creationId xmlns:a16="http://schemas.microsoft.com/office/drawing/2014/main" xmlns="" id="{8E7F62E8-4B43-4F74-8C0C-00D567698A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32818" y="2856986"/>
              <a:ext cx="7159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 dirty="0"/>
                <a:t>Ca</a:t>
              </a:r>
              <a:r>
                <a:rPr lang="en-US" sz="1400" baseline="30000" dirty="0"/>
                <a:t>2+</a:t>
              </a:r>
            </a:p>
          </p:txBody>
        </p:sp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xmlns="" id="{0F441B80-B3C8-4522-BD99-1F8FB23B62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44" t="18243" r="25030" b="22508"/>
            <a:stretch/>
          </p:blipFill>
          <p:spPr>
            <a:xfrm>
              <a:off x="3323789" y="3115616"/>
              <a:ext cx="1625978" cy="2386711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887D40EE-D0BD-4538-B050-671493847655}"/>
                </a:ext>
              </a:extLst>
            </p:cNvPr>
            <p:cNvSpPr txBox="1"/>
            <p:nvPr/>
          </p:nvSpPr>
          <p:spPr>
            <a:xfrm>
              <a:off x="3686912" y="2895797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428997D3-D774-434D-9D0D-22C39349D8DB}"/>
                </a:ext>
              </a:extLst>
            </p:cNvPr>
            <p:cNvSpPr txBox="1"/>
            <p:nvPr/>
          </p:nvSpPr>
          <p:spPr>
            <a:xfrm>
              <a:off x="4000352" y="2897850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02B4C5D7-0881-42D9-BB6C-ECE2DB45798E}"/>
                </a:ext>
              </a:extLst>
            </p:cNvPr>
            <p:cNvSpPr txBox="1"/>
            <p:nvPr/>
          </p:nvSpPr>
          <p:spPr>
            <a:xfrm>
              <a:off x="4360677" y="2895798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01A2BC8A-70F1-4876-87FE-7F136A2C15E0}"/>
                </a:ext>
              </a:extLst>
            </p:cNvPr>
            <p:cNvSpPr txBox="1"/>
            <p:nvPr/>
          </p:nvSpPr>
          <p:spPr>
            <a:xfrm>
              <a:off x="4658075" y="2905872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3" name="TextBox 7">
              <a:extLst>
                <a:ext uri="{FF2B5EF4-FFF2-40B4-BE49-F238E27FC236}">
                  <a16:creationId xmlns:a16="http://schemas.microsoft.com/office/drawing/2014/main" xmlns="" id="{44F3517C-E0C6-43B7-95CC-AC5C7E76B0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41200">
              <a:off x="3658698" y="1893769"/>
              <a:ext cx="188032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YLRA (PCD1 +)</a:t>
              </a:r>
            </a:p>
          </p:txBody>
        </p:sp>
        <p:sp>
          <p:nvSpPr>
            <p:cNvPr id="74" name="TextBox 22">
              <a:extLst>
                <a:ext uri="{FF2B5EF4-FFF2-40B4-BE49-F238E27FC236}">
                  <a16:creationId xmlns:a16="http://schemas.microsoft.com/office/drawing/2014/main" xmlns="" id="{5C15673D-6857-4475-AA95-02D3C4EFEE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29540">
              <a:off x="4183146" y="1917730"/>
              <a:ext cx="182204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</a:t>
              </a:r>
              <a:r>
                <a:rPr lang="en-US" sz="1200" dirty="0" err="1"/>
                <a:t>YlrA</a:t>
              </a:r>
              <a:r>
                <a:rPr lang="en-US" sz="1200" dirty="0"/>
                <a:t> (PCD1 -)</a:t>
              </a:r>
            </a:p>
          </p:txBody>
        </p:sp>
        <p:sp>
          <p:nvSpPr>
            <p:cNvPr id="77" name="Right Brace 29">
              <a:extLst>
                <a:ext uri="{FF2B5EF4-FFF2-40B4-BE49-F238E27FC236}">
                  <a16:creationId xmlns:a16="http://schemas.microsoft.com/office/drawing/2014/main" xmlns="" id="{856EF976-C6B1-4C4E-BCD2-AFF4D93A3541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4574227" y="2528522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80" name="Right Brace 29">
              <a:extLst>
                <a:ext uri="{FF2B5EF4-FFF2-40B4-BE49-F238E27FC236}">
                  <a16:creationId xmlns:a16="http://schemas.microsoft.com/office/drawing/2014/main" xmlns="" id="{8907FD4E-F58C-4AA1-AA27-77BB9744F68B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3931649" y="2528744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0AE424AD-6BF0-4A46-89E2-85453217C7B6}"/>
                </a:ext>
              </a:extLst>
            </p:cNvPr>
            <p:cNvSpPr txBox="1"/>
            <p:nvPr/>
          </p:nvSpPr>
          <p:spPr>
            <a:xfrm>
              <a:off x="2893180" y="3449621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xmlns="" id="{F470ABDE-DEF2-4877-83C3-EE3E3FCA331B}"/>
                </a:ext>
              </a:extLst>
            </p:cNvPr>
            <p:cNvSpPr txBox="1"/>
            <p:nvPr/>
          </p:nvSpPr>
          <p:spPr>
            <a:xfrm>
              <a:off x="2985417" y="377642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xmlns="" id="{DAFE32CB-F3FC-408B-A38E-7CB09D6B4FC0}"/>
                </a:ext>
              </a:extLst>
            </p:cNvPr>
            <p:cNvSpPr txBox="1"/>
            <p:nvPr/>
          </p:nvSpPr>
          <p:spPr>
            <a:xfrm>
              <a:off x="2988400" y="411087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A5D2D197-5B21-4003-823D-0FC0495332E2}"/>
                </a:ext>
              </a:extLst>
            </p:cNvPr>
            <p:cNvSpPr txBox="1"/>
            <p:nvPr/>
          </p:nvSpPr>
          <p:spPr>
            <a:xfrm>
              <a:off x="2985417" y="482642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A090E1DC-BBE1-4090-B236-09E968C34D63}"/>
                </a:ext>
              </a:extLst>
            </p:cNvPr>
            <p:cNvSpPr txBox="1"/>
            <p:nvPr/>
          </p:nvSpPr>
          <p:spPr>
            <a:xfrm>
              <a:off x="2971732" y="527783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69D26313-BC2E-4E0E-93DE-9AEA0F31EAE3}"/>
                </a:ext>
              </a:extLst>
            </p:cNvPr>
            <p:cNvSpPr txBox="1"/>
            <p:nvPr/>
          </p:nvSpPr>
          <p:spPr>
            <a:xfrm>
              <a:off x="2923642" y="2890007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0B71F49A-27A5-4A18-B3A2-6DBC68D2CCE7}"/>
                </a:ext>
              </a:extLst>
            </p:cNvPr>
            <p:cNvSpPr txBox="1"/>
            <p:nvPr/>
          </p:nvSpPr>
          <p:spPr>
            <a:xfrm>
              <a:off x="2875024" y="3305144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10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xmlns="" id="{82E40709-C7F4-4B36-9808-B01368304188}"/>
                </a:ext>
              </a:extLst>
            </p:cNvPr>
            <p:cNvSpPr txBox="1"/>
            <p:nvPr/>
          </p:nvSpPr>
          <p:spPr>
            <a:xfrm>
              <a:off x="4998634" y="3531500"/>
              <a:ext cx="45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YlrA</a:t>
              </a:r>
              <a:endParaRPr lang="en-US" sz="1200" dirty="0"/>
            </a:p>
          </p:txBody>
        </p:sp>
        <p:sp>
          <p:nvSpPr>
            <p:cNvPr id="7" name="Isosceles Triangle 6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4947512" y="3622042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618187" y="425002"/>
            <a:ext cx="30909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2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5924481" y="879939"/>
            <a:ext cx="2615895" cy="4406005"/>
            <a:chOff x="3451735" y="1145209"/>
            <a:chExt cx="2615895" cy="4406005"/>
          </a:xfrm>
        </p:grpSpPr>
        <p:grpSp>
          <p:nvGrpSpPr>
            <p:cNvPr id="9" name="Group 8"/>
            <p:cNvGrpSpPr/>
            <p:nvPr/>
          </p:nvGrpSpPr>
          <p:grpSpPr>
            <a:xfrm>
              <a:off x="3451735" y="1145209"/>
              <a:ext cx="2615895" cy="4406005"/>
              <a:chOff x="3451735" y="1145209"/>
              <a:chExt cx="2615895" cy="4406005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3451735" y="1145209"/>
                <a:ext cx="2615895" cy="4406005"/>
                <a:chOff x="6877518" y="1145209"/>
                <a:chExt cx="2615895" cy="4406005"/>
              </a:xfrm>
            </p:grpSpPr>
            <p:pic>
              <p:nvPicPr>
                <p:cNvPr id="56" name="Picture 55">
                  <a:extLst>
                    <a:ext uri="{FF2B5EF4-FFF2-40B4-BE49-F238E27FC236}">
                      <a16:creationId xmlns:a16="http://schemas.microsoft.com/office/drawing/2014/main" xmlns="" id="{33593F5A-ED50-4F73-911B-495130697B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775" t="28311" r="41788" b="9440"/>
                <a:stretch/>
              </p:blipFill>
              <p:spPr>
                <a:xfrm>
                  <a:off x="7305008" y="3103384"/>
                  <a:ext cx="1614416" cy="2447830"/>
                </a:xfrm>
                <a:prstGeom prst="rect">
                  <a:avLst/>
                </a:prstGeom>
              </p:spPr>
            </p:pic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xmlns="" id="{3A019359-C2AA-4773-AC91-1A4B4389811B}"/>
                    </a:ext>
                  </a:extLst>
                </p:cNvPr>
                <p:cNvSpPr txBox="1"/>
                <p:nvPr/>
              </p:nvSpPr>
              <p:spPr>
                <a:xfrm>
                  <a:off x="7641298" y="2895798"/>
                  <a:ext cx="2935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xmlns="" id="{8D219EF1-F90A-4D9C-AF78-D5AFEFBE5EC2}"/>
                    </a:ext>
                  </a:extLst>
                </p:cNvPr>
                <p:cNvSpPr txBox="1"/>
                <p:nvPr/>
              </p:nvSpPr>
              <p:spPr>
                <a:xfrm>
                  <a:off x="7962759" y="2897851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xmlns="" id="{0B7D632B-8CE2-4EE6-AF59-1C5655F57391}"/>
                    </a:ext>
                  </a:extLst>
                </p:cNvPr>
                <p:cNvSpPr txBox="1"/>
                <p:nvPr/>
              </p:nvSpPr>
              <p:spPr>
                <a:xfrm>
                  <a:off x="8315063" y="2895799"/>
                  <a:ext cx="2935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xmlns="" id="{DCBE3AA6-3D7F-436E-96F3-BDE859718F12}"/>
                    </a:ext>
                  </a:extLst>
                </p:cNvPr>
                <p:cNvSpPr txBox="1"/>
                <p:nvPr/>
              </p:nvSpPr>
              <p:spPr>
                <a:xfrm>
                  <a:off x="8612461" y="2905873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90" name="TextBox 7">
                  <a:extLst>
                    <a:ext uri="{FF2B5EF4-FFF2-40B4-BE49-F238E27FC236}">
                      <a16:creationId xmlns:a16="http://schemas.microsoft.com/office/drawing/2014/main" xmlns="" id="{5ADAD573-23E1-449A-8275-4814ADC5B38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8941200">
                  <a:off x="7613084" y="1893770"/>
                  <a:ext cx="1880329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 err="1"/>
                    <a:t>Yp</a:t>
                  </a:r>
                  <a:r>
                    <a:rPr lang="en-US" sz="1200" dirty="0"/>
                    <a:t> FLAG-CTC YLRA (PCD1 +)</a:t>
                  </a:r>
                </a:p>
              </p:txBody>
            </p:sp>
            <p:sp>
              <p:nvSpPr>
                <p:cNvPr id="91" name="TextBox 22">
                  <a:extLst>
                    <a:ext uri="{FF2B5EF4-FFF2-40B4-BE49-F238E27FC236}">
                      <a16:creationId xmlns:a16="http://schemas.microsoft.com/office/drawing/2014/main" xmlns="" id="{B6A8D5A2-03FA-4F01-BE45-592514D2D75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8829540">
                  <a:off x="8137532" y="1917731"/>
                  <a:ext cx="1822043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 err="1"/>
                    <a:t>Yp</a:t>
                  </a:r>
                  <a:r>
                    <a:rPr lang="en-US" sz="1200" dirty="0"/>
                    <a:t> FLAG-CTC </a:t>
                  </a:r>
                  <a:r>
                    <a:rPr lang="en-US" sz="1200" dirty="0" err="1"/>
                    <a:t>YlrA</a:t>
                  </a:r>
                  <a:r>
                    <a:rPr lang="en-US" sz="1200" dirty="0"/>
                    <a:t> (PCD1 -)</a:t>
                  </a:r>
                </a:p>
              </p:txBody>
            </p:sp>
            <p:sp>
              <p:nvSpPr>
                <p:cNvPr id="92" name="Right Brace 29">
                  <a:extLst>
                    <a:ext uri="{FF2B5EF4-FFF2-40B4-BE49-F238E27FC236}">
                      <a16:creationId xmlns:a16="http://schemas.microsoft.com/office/drawing/2014/main" xmlns="" id="{0DEFDD09-BA81-46BC-88D1-AE6E73EAB1E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8528613" y="2528523"/>
                  <a:ext cx="52436" cy="587650"/>
                </a:xfrm>
                <a:prstGeom prst="rightBrace">
                  <a:avLst>
                    <a:gd name="adj1" fmla="val 36282"/>
                    <a:gd name="adj2" fmla="val 50000"/>
                  </a:avLst>
                </a:prstGeom>
                <a:noFill/>
                <a:ln w="19050" algn="ctr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vert="eaVert" anchor="ctr"/>
                <a:lstStyle/>
                <a:p>
                  <a:pPr algn="ctr">
                    <a:defRPr/>
                  </a:pPr>
                  <a:endParaRPr lang="en-US">
                    <a:solidFill>
                      <a:srgbClr val="000000"/>
                    </a:solidFill>
                    <a:latin typeface="+mn-lt"/>
                  </a:endParaRPr>
                </a:p>
              </p:txBody>
            </p:sp>
            <p:sp>
              <p:nvSpPr>
                <p:cNvPr id="93" name="Right Brace 29">
                  <a:extLst>
                    <a:ext uri="{FF2B5EF4-FFF2-40B4-BE49-F238E27FC236}">
                      <a16:creationId xmlns:a16="http://schemas.microsoft.com/office/drawing/2014/main" xmlns="" id="{3FE585A0-8426-49AF-8A2A-DAD55BEBB3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886035" y="2528745"/>
                  <a:ext cx="52436" cy="587650"/>
                </a:xfrm>
                <a:prstGeom prst="rightBrace">
                  <a:avLst>
                    <a:gd name="adj1" fmla="val 36282"/>
                    <a:gd name="adj2" fmla="val 50000"/>
                  </a:avLst>
                </a:prstGeom>
                <a:noFill/>
                <a:ln w="19050" algn="ctr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vert="eaVert" anchor="ctr"/>
                <a:lstStyle/>
                <a:p>
                  <a:pPr algn="ctr">
                    <a:defRPr/>
                  </a:pPr>
                  <a:endParaRPr lang="en-US">
                    <a:solidFill>
                      <a:srgbClr val="000000"/>
                    </a:solidFill>
                    <a:latin typeface="+mn-lt"/>
                  </a:endParaRPr>
                </a:p>
              </p:txBody>
            </p:sp>
            <p:sp>
              <p:nvSpPr>
                <p:cNvPr id="94" name="TextBox 12">
                  <a:extLst>
                    <a:ext uri="{FF2B5EF4-FFF2-40B4-BE49-F238E27FC236}">
                      <a16:creationId xmlns:a16="http://schemas.microsoft.com/office/drawing/2014/main" xmlns="" id="{75EB3C37-2D7B-4789-944F-0821F10590E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267412" y="2848966"/>
                  <a:ext cx="715918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 dirty="0"/>
                    <a:t>Ca</a:t>
                  </a:r>
                  <a:r>
                    <a:rPr lang="en-US" sz="1400" baseline="30000" dirty="0"/>
                    <a:t>2+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xmlns="" id="{39C8811E-0D42-4DCC-ACA0-7B473E38B4E8}"/>
                    </a:ext>
                  </a:extLst>
                </p:cNvPr>
                <p:cNvSpPr txBox="1"/>
                <p:nvPr/>
              </p:nvSpPr>
              <p:spPr>
                <a:xfrm>
                  <a:off x="6911730" y="3441601"/>
                  <a:ext cx="3738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  75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xmlns="" id="{4882D50A-157C-4052-AEF1-3DD1439CE651}"/>
                    </a:ext>
                  </a:extLst>
                </p:cNvPr>
                <p:cNvSpPr txBox="1"/>
                <p:nvPr/>
              </p:nvSpPr>
              <p:spPr>
                <a:xfrm>
                  <a:off x="7003967" y="3768406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0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xmlns="" id="{412759D3-3214-489E-AC1A-D9EC3F8BCF8B}"/>
                    </a:ext>
                  </a:extLst>
                </p:cNvPr>
                <p:cNvSpPr txBox="1"/>
                <p:nvPr/>
              </p:nvSpPr>
              <p:spPr>
                <a:xfrm>
                  <a:off x="7006950" y="4102858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37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xmlns="" id="{8CD39641-A094-4E0C-8FB1-90BACBB9B384}"/>
                    </a:ext>
                  </a:extLst>
                </p:cNvPr>
                <p:cNvSpPr txBox="1"/>
                <p:nvPr/>
              </p:nvSpPr>
              <p:spPr>
                <a:xfrm>
                  <a:off x="7003967" y="481840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5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xmlns="" id="{0C1BE324-6995-479A-85C4-965A8DD9FFEA}"/>
                    </a:ext>
                  </a:extLst>
                </p:cNvPr>
                <p:cNvSpPr txBox="1"/>
                <p:nvPr/>
              </p:nvSpPr>
              <p:spPr>
                <a:xfrm>
                  <a:off x="6990282" y="526981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20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xmlns="" id="{4DE34453-A95B-4C68-96D1-C4F2A34B4001}"/>
                    </a:ext>
                  </a:extLst>
                </p:cNvPr>
                <p:cNvSpPr txBox="1"/>
                <p:nvPr/>
              </p:nvSpPr>
              <p:spPr>
                <a:xfrm>
                  <a:off x="6942192" y="2881987"/>
                  <a:ext cx="4331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xmlns="" id="{B5B577DE-1C37-4014-85F6-A50706FD4F1F}"/>
                    </a:ext>
                  </a:extLst>
                </p:cNvPr>
                <p:cNvSpPr txBox="1"/>
                <p:nvPr/>
              </p:nvSpPr>
              <p:spPr>
                <a:xfrm>
                  <a:off x="6877518" y="3297124"/>
                  <a:ext cx="43954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  100</a:t>
                  </a:r>
                </a:p>
              </p:txBody>
            </p:sp>
          </p:grp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xmlns="" id="{82E40709-C7F4-4B36-9808-B01368304188}"/>
                  </a:ext>
                </a:extLst>
              </p:cNvPr>
              <p:cNvSpPr txBox="1"/>
              <p:nvPr/>
            </p:nvSpPr>
            <p:spPr>
              <a:xfrm>
                <a:off x="5550286" y="3529352"/>
                <a:ext cx="4566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/>
                  <a:t>YlrA</a:t>
                </a:r>
                <a:endParaRPr lang="en-US" sz="1200" dirty="0"/>
              </a:p>
            </p:txBody>
          </p:sp>
        </p:grpSp>
        <p:sp>
          <p:nvSpPr>
            <p:cNvPr id="46" name="Isosceles Triangle 45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5500226" y="3619894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4134116" y="5208252"/>
            <a:ext cx="3494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ernatant                             Pellet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697337" y="5546869"/>
            <a:ext cx="892871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d secretion of FLAG-tagged 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lrA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(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3S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(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ndicated strains possessing a FLAG-tagge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ncoding plasmid were propagated either in 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ce (+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absenc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 of 2.5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lcium for 5 hr at 37 °C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ion, but not expression, of T3SS substrates occurs in the absence of calcium.) Culture supernatants and bacterial cells were collected and analyzed by western blotting using an anti-FLAG antibody. </a:t>
            </a:r>
          </a:p>
        </p:txBody>
      </p:sp>
    </p:spTree>
    <p:extLst>
      <p:ext uri="{BB962C8B-B14F-4D97-AF65-F5344CB8AC3E}">
        <p14:creationId xmlns:p14="http://schemas.microsoft.com/office/powerpoint/2010/main" val="2326852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618187" y="425002"/>
            <a:ext cx="30909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3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730097" y="663237"/>
            <a:ext cx="2663952" cy="4646833"/>
            <a:chOff x="1399192" y="906117"/>
            <a:chExt cx="2663952" cy="464683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7772EFE6-C238-4F56-A099-41A4822D9A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05" t="18123" r="21161" b="19399"/>
            <a:stretch/>
          </p:blipFill>
          <p:spPr>
            <a:xfrm>
              <a:off x="1854036" y="3048216"/>
              <a:ext cx="1629474" cy="2504734"/>
            </a:xfrm>
            <a:prstGeom prst="rect">
              <a:avLst/>
            </a:prstGeom>
          </p:spPr>
        </p:pic>
        <p:sp>
          <p:nvSpPr>
            <p:cNvPr id="23" name="TextBox 12">
              <a:extLst>
                <a:ext uri="{FF2B5EF4-FFF2-40B4-BE49-F238E27FC236}">
                  <a16:creationId xmlns:a16="http://schemas.microsoft.com/office/drawing/2014/main" xmlns="" id="{41E2A4A3-9CF9-48AB-97A6-69375C3B4B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6935" y="2792818"/>
              <a:ext cx="7159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 dirty="0"/>
                <a:t>Ca</a:t>
              </a:r>
              <a:r>
                <a:rPr lang="en-US" sz="1400" baseline="30000" dirty="0"/>
                <a:t>2+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0B1E5684-DEAB-4300-A973-F8080FDF4B39}"/>
                </a:ext>
              </a:extLst>
            </p:cNvPr>
            <p:cNvSpPr txBox="1"/>
            <p:nvPr/>
          </p:nvSpPr>
          <p:spPr>
            <a:xfrm>
              <a:off x="2211029" y="2831629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B380EF74-B0F8-4225-B11C-226ABA08CF1B}"/>
                </a:ext>
              </a:extLst>
            </p:cNvPr>
            <p:cNvSpPr txBox="1"/>
            <p:nvPr/>
          </p:nvSpPr>
          <p:spPr>
            <a:xfrm>
              <a:off x="2532490" y="2833682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E3065588-9EE1-4120-B324-6CDE21B13E7B}"/>
                </a:ext>
              </a:extLst>
            </p:cNvPr>
            <p:cNvSpPr txBox="1"/>
            <p:nvPr/>
          </p:nvSpPr>
          <p:spPr>
            <a:xfrm>
              <a:off x="2884794" y="2831630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60CBDE32-F25B-4842-A5E8-C94A245DDDBB}"/>
                </a:ext>
              </a:extLst>
            </p:cNvPr>
            <p:cNvSpPr txBox="1"/>
            <p:nvPr/>
          </p:nvSpPr>
          <p:spPr>
            <a:xfrm>
              <a:off x="3182192" y="2841704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" name="TextBox 7">
              <a:extLst>
                <a:ext uri="{FF2B5EF4-FFF2-40B4-BE49-F238E27FC236}">
                  <a16:creationId xmlns:a16="http://schemas.microsoft.com/office/drawing/2014/main" xmlns="" id="{D3C0ABD4-61D7-4AF5-82D4-2BFBD28F4E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41200">
              <a:off x="2182815" y="1829601"/>
              <a:ext cx="188032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YLRB (PCD1 +)</a:t>
              </a:r>
            </a:p>
          </p:txBody>
        </p:sp>
        <p:sp>
          <p:nvSpPr>
            <p:cNvPr id="31" name="TextBox 22">
              <a:extLst>
                <a:ext uri="{FF2B5EF4-FFF2-40B4-BE49-F238E27FC236}">
                  <a16:creationId xmlns:a16="http://schemas.microsoft.com/office/drawing/2014/main" xmlns="" id="{6C1287B7-B1F3-4C9D-992D-35A23B11DE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29540">
              <a:off x="2676014" y="1780252"/>
              <a:ext cx="202527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</a:t>
              </a:r>
              <a:r>
                <a:rPr lang="en-US" sz="1200" dirty="0" err="1"/>
                <a:t>YlrAB</a:t>
              </a:r>
              <a:r>
                <a:rPr lang="en-US" sz="1200" dirty="0"/>
                <a:t>(PCD1 -)</a:t>
              </a:r>
            </a:p>
          </p:txBody>
        </p:sp>
        <p:sp>
          <p:nvSpPr>
            <p:cNvPr id="32" name="Right Brace 29">
              <a:extLst>
                <a:ext uri="{FF2B5EF4-FFF2-40B4-BE49-F238E27FC236}">
                  <a16:creationId xmlns:a16="http://schemas.microsoft.com/office/drawing/2014/main" xmlns="" id="{9EFAFED4-6FD3-42B5-A209-F9D670B831FC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3098344" y="2464354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33" name="Right Brace 29">
              <a:extLst>
                <a:ext uri="{FF2B5EF4-FFF2-40B4-BE49-F238E27FC236}">
                  <a16:creationId xmlns:a16="http://schemas.microsoft.com/office/drawing/2014/main" xmlns="" id="{894EBA65-D47E-4CE0-A94F-73547D3F5866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2455766" y="2464576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D451543B-9C6A-4F25-B011-A909E80DC651}"/>
                </a:ext>
              </a:extLst>
            </p:cNvPr>
            <p:cNvSpPr txBox="1"/>
            <p:nvPr/>
          </p:nvSpPr>
          <p:spPr>
            <a:xfrm>
              <a:off x="1417348" y="3217012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BAC8E796-A45B-43C8-91D9-41F0E1B0C026}"/>
                </a:ext>
              </a:extLst>
            </p:cNvPr>
            <p:cNvSpPr txBox="1"/>
            <p:nvPr/>
          </p:nvSpPr>
          <p:spPr>
            <a:xfrm>
              <a:off x="1509585" y="361600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7611485B-09FE-433F-A21F-5EBF84138B82}"/>
                </a:ext>
              </a:extLst>
            </p:cNvPr>
            <p:cNvSpPr txBox="1"/>
            <p:nvPr/>
          </p:nvSpPr>
          <p:spPr>
            <a:xfrm>
              <a:off x="1512568" y="395045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E02F5532-3039-4D38-B286-9A1010463347}"/>
                </a:ext>
              </a:extLst>
            </p:cNvPr>
            <p:cNvSpPr txBox="1"/>
            <p:nvPr/>
          </p:nvSpPr>
          <p:spPr>
            <a:xfrm>
              <a:off x="1509585" y="477027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3D890EFC-91C4-4D79-B68B-E4AD3A6590BE}"/>
                </a:ext>
              </a:extLst>
            </p:cNvPr>
            <p:cNvSpPr txBox="1"/>
            <p:nvPr/>
          </p:nvSpPr>
          <p:spPr>
            <a:xfrm>
              <a:off x="1471837" y="522970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3590CDF7-CDBD-405E-8A2C-4725FFFDBDDA}"/>
                </a:ext>
              </a:extLst>
            </p:cNvPr>
            <p:cNvSpPr txBox="1"/>
            <p:nvPr/>
          </p:nvSpPr>
          <p:spPr>
            <a:xfrm>
              <a:off x="1415233" y="3216912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xmlns="" id="{A041806B-C04D-4018-88C3-5DF468498855}"/>
                </a:ext>
              </a:extLst>
            </p:cNvPr>
            <p:cNvSpPr txBox="1"/>
            <p:nvPr/>
          </p:nvSpPr>
          <p:spPr>
            <a:xfrm>
              <a:off x="1399192" y="2992325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10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xmlns="" id="{74569826-D82D-4A4F-A8C1-21DC43145F25}"/>
                </a:ext>
              </a:extLst>
            </p:cNvPr>
            <p:cNvSpPr txBox="1"/>
            <p:nvPr/>
          </p:nvSpPr>
          <p:spPr>
            <a:xfrm>
              <a:off x="1431762" y="2809797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82E40709-C7F4-4B36-9808-B01368304188}"/>
                </a:ext>
              </a:extLst>
            </p:cNvPr>
            <p:cNvSpPr txBox="1"/>
            <p:nvPr/>
          </p:nvSpPr>
          <p:spPr>
            <a:xfrm>
              <a:off x="3530439" y="4111046"/>
              <a:ext cx="45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YlrB</a:t>
              </a:r>
              <a:endParaRPr lang="en-US" sz="1200" dirty="0"/>
            </a:p>
          </p:txBody>
        </p:sp>
        <p:sp>
          <p:nvSpPr>
            <p:cNvPr id="47" name="Isosceles Triangle 46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3479317" y="4201588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6148104" y="857046"/>
            <a:ext cx="2601983" cy="4453024"/>
            <a:chOff x="5104915" y="1089062"/>
            <a:chExt cx="2601983" cy="445302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6AAFCABE-8D4C-450F-AFD6-9092F78EE9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16" t="19146" r="31461" b="18065"/>
            <a:stretch/>
          </p:blipFill>
          <p:spPr>
            <a:xfrm>
              <a:off x="5588743" y="3048650"/>
              <a:ext cx="1453734" cy="248584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9A9D10DA-7CBF-4F06-82FF-DB49B9B44365}"/>
                </a:ext>
              </a:extLst>
            </p:cNvPr>
            <p:cNvSpPr txBox="1"/>
            <p:nvPr/>
          </p:nvSpPr>
          <p:spPr>
            <a:xfrm>
              <a:off x="5123071" y="3225032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9E706CD1-5E58-4D55-9EE7-FE8641C0EB16}"/>
                </a:ext>
              </a:extLst>
            </p:cNvPr>
            <p:cNvSpPr txBox="1"/>
            <p:nvPr/>
          </p:nvSpPr>
          <p:spPr>
            <a:xfrm>
              <a:off x="5215308" y="362402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E2B7EC8A-2BBB-4933-84FA-EACFF0F0453F}"/>
                </a:ext>
              </a:extLst>
            </p:cNvPr>
            <p:cNvSpPr txBox="1"/>
            <p:nvPr/>
          </p:nvSpPr>
          <p:spPr>
            <a:xfrm>
              <a:off x="5218291" y="395847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6CE02B87-C11F-4575-A330-9C287C82AFDD}"/>
                </a:ext>
              </a:extLst>
            </p:cNvPr>
            <p:cNvSpPr txBox="1"/>
            <p:nvPr/>
          </p:nvSpPr>
          <p:spPr>
            <a:xfrm>
              <a:off x="5215308" y="477829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A639BAD6-6BA4-42B4-B55E-789969CD1B08}"/>
                </a:ext>
              </a:extLst>
            </p:cNvPr>
            <p:cNvSpPr txBox="1"/>
            <p:nvPr/>
          </p:nvSpPr>
          <p:spPr>
            <a:xfrm>
              <a:off x="5177560" y="523772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0CC0DC70-95B7-49F9-B731-A5E280ED619A}"/>
                </a:ext>
              </a:extLst>
            </p:cNvPr>
            <p:cNvSpPr txBox="1"/>
            <p:nvPr/>
          </p:nvSpPr>
          <p:spPr>
            <a:xfrm>
              <a:off x="5153533" y="2825838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55028603-4165-440B-8C5E-61345B1A76DD}"/>
                </a:ext>
              </a:extLst>
            </p:cNvPr>
            <p:cNvSpPr txBox="1"/>
            <p:nvPr/>
          </p:nvSpPr>
          <p:spPr>
            <a:xfrm>
              <a:off x="5836549" y="2839651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02DFDFB9-1A4A-4902-A2E2-AB32F542EAAB}"/>
                </a:ext>
              </a:extLst>
            </p:cNvPr>
            <p:cNvSpPr txBox="1"/>
            <p:nvPr/>
          </p:nvSpPr>
          <p:spPr>
            <a:xfrm>
              <a:off x="6141968" y="2841704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90199070-2031-4901-99C3-CBB0B3C63639}"/>
                </a:ext>
              </a:extLst>
            </p:cNvPr>
            <p:cNvSpPr txBox="1"/>
            <p:nvPr/>
          </p:nvSpPr>
          <p:spPr>
            <a:xfrm>
              <a:off x="6510314" y="2839652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FC0429F5-D6E3-4299-A595-7E470CFEEA72}"/>
                </a:ext>
              </a:extLst>
            </p:cNvPr>
            <p:cNvSpPr txBox="1"/>
            <p:nvPr/>
          </p:nvSpPr>
          <p:spPr>
            <a:xfrm>
              <a:off x="6807712" y="284972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" name="TextBox 7">
              <a:extLst>
                <a:ext uri="{FF2B5EF4-FFF2-40B4-BE49-F238E27FC236}">
                  <a16:creationId xmlns:a16="http://schemas.microsoft.com/office/drawing/2014/main" xmlns="" id="{2FAE7C81-0021-44D7-B8CE-D8E70DB65D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41200">
              <a:off x="5808335" y="1837623"/>
              <a:ext cx="188032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YLRB (PCD1 +)</a:t>
              </a:r>
            </a:p>
          </p:txBody>
        </p:sp>
        <p:sp>
          <p:nvSpPr>
            <p:cNvPr id="39" name="TextBox 22">
              <a:extLst>
                <a:ext uri="{FF2B5EF4-FFF2-40B4-BE49-F238E27FC236}">
                  <a16:creationId xmlns:a16="http://schemas.microsoft.com/office/drawing/2014/main" xmlns="" id="{856CD2E8-6690-4E04-B1BC-3B7D79DF96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29540">
              <a:off x="6332783" y="1861584"/>
              <a:ext cx="182204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</a:t>
              </a:r>
              <a:r>
                <a:rPr lang="en-US" sz="1200" dirty="0" err="1"/>
                <a:t>YlrB</a:t>
              </a:r>
              <a:r>
                <a:rPr lang="en-US" sz="1200" dirty="0"/>
                <a:t> (PCD1 -)</a:t>
              </a:r>
            </a:p>
          </p:txBody>
        </p:sp>
        <p:sp>
          <p:nvSpPr>
            <p:cNvPr id="40" name="Right Brace 29">
              <a:extLst>
                <a:ext uri="{FF2B5EF4-FFF2-40B4-BE49-F238E27FC236}">
                  <a16:creationId xmlns:a16="http://schemas.microsoft.com/office/drawing/2014/main" xmlns="" id="{C4A8B46D-B5BA-4304-9FDC-0543A92BEBE9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6723864" y="2472376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41" name="Right Brace 29">
              <a:extLst>
                <a:ext uri="{FF2B5EF4-FFF2-40B4-BE49-F238E27FC236}">
                  <a16:creationId xmlns:a16="http://schemas.microsoft.com/office/drawing/2014/main" xmlns="" id="{31E06D26-7F1B-490C-A390-C9E5E85C3F76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6081286" y="2472598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42" name="TextBox 12">
              <a:extLst>
                <a:ext uri="{FF2B5EF4-FFF2-40B4-BE49-F238E27FC236}">
                  <a16:creationId xmlns:a16="http://schemas.microsoft.com/office/drawing/2014/main" xmlns="" id="{7505D559-87B7-4F9E-AF12-1E3F062372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62663" y="2792819"/>
              <a:ext cx="7159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 dirty="0"/>
                <a:t>Ca</a:t>
              </a:r>
              <a:r>
                <a:rPr lang="en-US" sz="1400" baseline="30000" dirty="0"/>
                <a:t>2+</a:t>
              </a:r>
            </a:p>
          </p:txBody>
        </p:sp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xmlns="" id="{48392E1E-A479-45E7-9E82-4BCD4D7835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16" t="19146" r="31461" b="18065"/>
            <a:stretch/>
          </p:blipFill>
          <p:spPr>
            <a:xfrm>
              <a:off x="5589940" y="3056237"/>
              <a:ext cx="1582840" cy="248584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F77DFEC4-FC97-4A60-9FB7-8A5F6F064DD2}"/>
                </a:ext>
              </a:extLst>
            </p:cNvPr>
            <p:cNvSpPr txBox="1"/>
            <p:nvPr/>
          </p:nvSpPr>
          <p:spPr>
            <a:xfrm>
              <a:off x="5120956" y="3224932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77B61F33-6D0F-41F7-A8F1-9991561AE25E}"/>
                </a:ext>
              </a:extLst>
            </p:cNvPr>
            <p:cNvSpPr txBox="1"/>
            <p:nvPr/>
          </p:nvSpPr>
          <p:spPr>
            <a:xfrm>
              <a:off x="5104915" y="3000345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10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82E40709-C7F4-4B36-9808-B01368304188}"/>
                </a:ext>
              </a:extLst>
            </p:cNvPr>
            <p:cNvSpPr txBox="1"/>
            <p:nvPr/>
          </p:nvSpPr>
          <p:spPr>
            <a:xfrm>
              <a:off x="7250289" y="4108898"/>
              <a:ext cx="45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YlrB</a:t>
              </a:r>
              <a:endParaRPr lang="en-US" sz="1200" dirty="0"/>
            </a:p>
          </p:txBody>
        </p:sp>
        <p:sp>
          <p:nvSpPr>
            <p:cNvPr id="49" name="Isosceles Triangle 48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7199167" y="4199440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4468970" y="5242275"/>
            <a:ext cx="3494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ernatant                             Pellet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697337" y="5546869"/>
            <a:ext cx="892871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d secretion of FLAG-tagged 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lrB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(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3S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(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ndicated strains possessing a FLAG-tagge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ncoding plasmid were propagated either in 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ce (+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absenc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 of 2.5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lcium for 5 hr at 37 °C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ion, but not expression, of T3SS substrates occurs in the absence of calcium.) Culture supernatants and bacterial cells were collected and analyzed by western blotting using an anti-FLAG antibody. </a:t>
            </a:r>
          </a:p>
        </p:txBody>
      </p:sp>
    </p:spTree>
    <p:extLst>
      <p:ext uri="{BB962C8B-B14F-4D97-AF65-F5344CB8AC3E}">
        <p14:creationId xmlns:p14="http://schemas.microsoft.com/office/powerpoint/2010/main" val="3977459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841449" y="399394"/>
            <a:ext cx="2644620" cy="4852530"/>
            <a:chOff x="2308861" y="583738"/>
            <a:chExt cx="2644620" cy="4852530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xmlns="" id="{F8E12CBA-9488-438A-9C52-6EAF7583D3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duotone>
                <a:schemeClr val="accent3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00000"/>
                      </a14:imgEffect>
                      <a14:imgEffect>
                        <a14:brightnessContrast bright="17000" contrast="17000"/>
                      </a14:imgEffect>
                    </a14:imgLayer>
                  </a14:imgProps>
                </a:ext>
              </a:extLst>
            </a:blip>
            <a:srcRect l="3894" t="2747" r="59721" b="11114"/>
            <a:stretch/>
          </p:blipFill>
          <p:spPr>
            <a:xfrm>
              <a:off x="2698784" y="2569915"/>
              <a:ext cx="1615803" cy="2866353"/>
            </a:xfrm>
            <a:prstGeom prst="rect">
              <a:avLst/>
            </a:prstGeom>
          </p:spPr>
        </p:pic>
        <p:sp>
          <p:nvSpPr>
            <p:cNvPr id="44" name="TextBox 12">
              <a:extLst>
                <a:ext uri="{FF2B5EF4-FFF2-40B4-BE49-F238E27FC236}">
                  <a16:creationId xmlns:a16="http://schemas.microsoft.com/office/drawing/2014/main" xmlns="" id="{6055ECFC-522F-4D32-B243-D168CE2A63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7272" y="2295516"/>
              <a:ext cx="7159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 dirty="0"/>
                <a:t>Ca</a:t>
              </a:r>
              <a:r>
                <a:rPr lang="en-US" sz="1400" baseline="30000" dirty="0"/>
                <a:t>2+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D63D2180-E273-436E-B32F-B309888266AF}"/>
                </a:ext>
              </a:extLst>
            </p:cNvPr>
            <p:cNvSpPr txBox="1"/>
            <p:nvPr/>
          </p:nvSpPr>
          <p:spPr>
            <a:xfrm>
              <a:off x="3101366" y="2334327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145B04B0-E955-419C-A3A3-99AE3DF177EE}"/>
                </a:ext>
              </a:extLst>
            </p:cNvPr>
            <p:cNvSpPr txBox="1"/>
            <p:nvPr/>
          </p:nvSpPr>
          <p:spPr>
            <a:xfrm>
              <a:off x="3414806" y="2336380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8E3A6D5B-BCF9-4030-B4A0-B1B7D053E50D}"/>
                </a:ext>
              </a:extLst>
            </p:cNvPr>
            <p:cNvSpPr txBox="1"/>
            <p:nvPr/>
          </p:nvSpPr>
          <p:spPr>
            <a:xfrm>
              <a:off x="3751068" y="2334328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F0055717-F7B5-4050-BC50-F01057A400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41200">
              <a:off x="3073152" y="1332299"/>
              <a:ext cx="188032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YLRC (PCD1 +)</a:t>
              </a:r>
            </a:p>
          </p:txBody>
        </p:sp>
        <p:sp>
          <p:nvSpPr>
            <p:cNvPr id="49" name="TextBox 22">
              <a:extLst>
                <a:ext uri="{FF2B5EF4-FFF2-40B4-BE49-F238E27FC236}">
                  <a16:creationId xmlns:a16="http://schemas.microsoft.com/office/drawing/2014/main" xmlns="" id="{1A58CF87-0AA6-4AC1-8DF9-B6B76EAE57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29540">
              <a:off x="3597600" y="1356260"/>
              <a:ext cx="182204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</a:t>
              </a:r>
              <a:r>
                <a:rPr lang="en-US" sz="1200" dirty="0" err="1"/>
                <a:t>YlrC</a:t>
              </a:r>
              <a:r>
                <a:rPr lang="en-US" sz="1200" dirty="0"/>
                <a:t> (PCD1 -)</a:t>
              </a:r>
            </a:p>
          </p:txBody>
        </p:sp>
        <p:sp>
          <p:nvSpPr>
            <p:cNvPr id="50" name="Right Brace 29">
              <a:extLst>
                <a:ext uri="{FF2B5EF4-FFF2-40B4-BE49-F238E27FC236}">
                  <a16:creationId xmlns:a16="http://schemas.microsoft.com/office/drawing/2014/main" xmlns="" id="{C658025B-6D21-4D33-8986-6B9C4852A1F5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3988681" y="1967052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51" name="Right Brace 29">
              <a:extLst>
                <a:ext uri="{FF2B5EF4-FFF2-40B4-BE49-F238E27FC236}">
                  <a16:creationId xmlns:a16="http://schemas.microsoft.com/office/drawing/2014/main" xmlns="" id="{43119C12-5F80-4BF9-977A-D70340F2BF73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3346103" y="1967274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B35EB9D9-BACC-4978-8725-5A69AD3FA634}"/>
                </a:ext>
              </a:extLst>
            </p:cNvPr>
            <p:cNvSpPr txBox="1"/>
            <p:nvPr/>
          </p:nvSpPr>
          <p:spPr>
            <a:xfrm>
              <a:off x="4020565" y="2274445"/>
              <a:ext cx="2935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-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5E7480F3-6B7F-4BC0-871E-4326E92BD25D}"/>
                </a:ext>
              </a:extLst>
            </p:cNvPr>
            <p:cNvSpPr txBox="1"/>
            <p:nvPr/>
          </p:nvSpPr>
          <p:spPr>
            <a:xfrm>
              <a:off x="2433510" y="385413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E676BFB0-8140-4818-8F72-546E96376D62}"/>
                </a:ext>
              </a:extLst>
            </p:cNvPr>
            <p:cNvSpPr txBox="1"/>
            <p:nvPr/>
          </p:nvSpPr>
          <p:spPr>
            <a:xfrm>
              <a:off x="2436493" y="4169533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0060554C-77D2-42FF-984D-B2A9CEA2263B}"/>
                </a:ext>
              </a:extLst>
            </p:cNvPr>
            <p:cNvSpPr txBox="1"/>
            <p:nvPr/>
          </p:nvSpPr>
          <p:spPr>
            <a:xfrm>
              <a:off x="2433510" y="462739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FAE4716D-7FD6-43C9-B9FA-EC322A9E741D}"/>
                </a:ext>
              </a:extLst>
            </p:cNvPr>
            <p:cNvSpPr txBox="1"/>
            <p:nvPr/>
          </p:nvSpPr>
          <p:spPr>
            <a:xfrm>
              <a:off x="2395762" y="506778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67E1DF40-6AD2-409F-AEF9-CCA10D32F11C}"/>
                </a:ext>
              </a:extLst>
            </p:cNvPr>
            <p:cNvSpPr txBox="1"/>
            <p:nvPr/>
          </p:nvSpPr>
          <p:spPr>
            <a:xfrm>
              <a:off x="2339158" y="3521712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A88419BA-8EA5-488A-81D7-47465B847B89}"/>
                </a:ext>
              </a:extLst>
            </p:cNvPr>
            <p:cNvSpPr txBox="1"/>
            <p:nvPr/>
          </p:nvSpPr>
          <p:spPr>
            <a:xfrm>
              <a:off x="2323117" y="323045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100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xmlns="" id="{CD02F0C4-14B7-49D8-A738-CE4738337372}"/>
                </a:ext>
              </a:extLst>
            </p:cNvPr>
            <p:cNvSpPr txBox="1"/>
            <p:nvPr/>
          </p:nvSpPr>
          <p:spPr>
            <a:xfrm>
              <a:off x="2308861" y="2324078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82E40709-C7F4-4B36-9808-B01368304188}"/>
                </a:ext>
              </a:extLst>
            </p:cNvPr>
            <p:cNvSpPr txBox="1"/>
            <p:nvPr/>
          </p:nvSpPr>
          <p:spPr>
            <a:xfrm>
              <a:off x="4380442" y="3544376"/>
              <a:ext cx="45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YlrC</a:t>
              </a:r>
              <a:endParaRPr lang="en-US" sz="1200" dirty="0"/>
            </a:p>
          </p:txBody>
        </p:sp>
        <p:sp>
          <p:nvSpPr>
            <p:cNvPr id="66" name="Isosceles Triangle 65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4329320" y="3634918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6147436" y="475988"/>
            <a:ext cx="2591981" cy="4732211"/>
            <a:chOff x="6147436" y="776243"/>
            <a:chExt cx="2591981" cy="4732211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xmlns="" id="{BEBC042D-BCCB-4859-A0A7-AF36CE76E3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duotone>
                <a:schemeClr val="accent3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32000" contrast="40000"/>
                      </a14:imgEffect>
                    </a14:imgLayer>
                  </a14:imgProps>
                </a:ext>
              </a:extLst>
            </a:blip>
            <a:srcRect l="11186" t="49166" r="10388" b="16251"/>
            <a:stretch/>
          </p:blipFill>
          <p:spPr>
            <a:xfrm rot="16200000">
              <a:off x="5972649" y="3326459"/>
              <a:ext cx="2748187" cy="1615803"/>
            </a:xfrm>
            <a:prstGeom prst="rect">
              <a:avLst/>
            </a:prstGeom>
          </p:spPr>
        </p:pic>
        <p:sp>
          <p:nvSpPr>
            <p:cNvPr id="52" name="TextBox 12">
              <a:extLst>
                <a:ext uri="{FF2B5EF4-FFF2-40B4-BE49-F238E27FC236}">
                  <a16:creationId xmlns:a16="http://schemas.microsoft.com/office/drawing/2014/main" xmlns="" id="{5FA95E93-8F3D-42A6-AF01-A06B80241A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81334" y="2488021"/>
              <a:ext cx="71591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 dirty="0"/>
                <a:t>Ca</a:t>
              </a:r>
              <a:r>
                <a:rPr lang="en-US" sz="1400" baseline="30000" dirty="0"/>
                <a:t>2+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2415E741-7678-44FC-9502-9F5EAD58F5CE}"/>
                </a:ext>
              </a:extLst>
            </p:cNvPr>
            <p:cNvSpPr txBox="1"/>
            <p:nvPr/>
          </p:nvSpPr>
          <p:spPr>
            <a:xfrm>
              <a:off x="6887302" y="2526832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7B3E99DF-DC27-4FE9-94E6-A7109669A935}"/>
                </a:ext>
              </a:extLst>
            </p:cNvPr>
            <p:cNvSpPr txBox="1"/>
            <p:nvPr/>
          </p:nvSpPr>
          <p:spPr>
            <a:xfrm>
              <a:off x="7200742" y="252888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6D601498-6823-4F90-B648-480126DBAC2B}"/>
                </a:ext>
              </a:extLst>
            </p:cNvPr>
            <p:cNvSpPr txBox="1"/>
            <p:nvPr/>
          </p:nvSpPr>
          <p:spPr>
            <a:xfrm>
              <a:off x="7561067" y="2526833"/>
              <a:ext cx="2935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7A02D8D5-1360-4A53-A1EE-AACCE19C62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41200">
              <a:off x="6859088" y="1524804"/>
              <a:ext cx="188032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YLRC (PCD1 +)</a:t>
              </a:r>
            </a:p>
          </p:txBody>
        </p:sp>
        <p:sp>
          <p:nvSpPr>
            <p:cNvPr id="57" name="TextBox 22">
              <a:extLst>
                <a:ext uri="{FF2B5EF4-FFF2-40B4-BE49-F238E27FC236}">
                  <a16:creationId xmlns:a16="http://schemas.microsoft.com/office/drawing/2014/main" xmlns="" id="{E3D7C6F4-D7E3-4B47-BEE9-29316430ED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29540">
              <a:off x="7383536" y="1548765"/>
              <a:ext cx="182204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Yp</a:t>
              </a:r>
              <a:r>
                <a:rPr lang="en-US" sz="1200" dirty="0"/>
                <a:t> FLAG-CTC </a:t>
              </a:r>
              <a:r>
                <a:rPr lang="en-US" sz="1200" dirty="0" err="1"/>
                <a:t>YlrC</a:t>
              </a:r>
              <a:r>
                <a:rPr lang="en-US" sz="1200" dirty="0"/>
                <a:t> (PCD1 -)</a:t>
              </a:r>
            </a:p>
          </p:txBody>
        </p:sp>
        <p:sp>
          <p:nvSpPr>
            <p:cNvPr id="58" name="Right Brace 29">
              <a:extLst>
                <a:ext uri="{FF2B5EF4-FFF2-40B4-BE49-F238E27FC236}">
                  <a16:creationId xmlns:a16="http://schemas.microsoft.com/office/drawing/2014/main" xmlns="" id="{99811601-DFE6-4D1F-9CC8-3C5CF0540E1C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7774617" y="2159557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59" name="Right Brace 29">
              <a:extLst>
                <a:ext uri="{FF2B5EF4-FFF2-40B4-BE49-F238E27FC236}">
                  <a16:creationId xmlns:a16="http://schemas.microsoft.com/office/drawing/2014/main" xmlns="" id="{C667BFF6-10FF-4B8B-8C76-46E19598259E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7132039" y="2159779"/>
              <a:ext cx="52436" cy="587650"/>
            </a:xfrm>
            <a:prstGeom prst="rightBrace">
              <a:avLst>
                <a:gd name="adj1" fmla="val 36282"/>
                <a:gd name="adj2" fmla="val 50000"/>
              </a:avLst>
            </a:prstGeom>
            <a:noFill/>
            <a:ln w="19050" algn="ctr">
              <a:solidFill>
                <a:schemeClr val="tx1"/>
              </a:solidFill>
              <a:round/>
              <a:headEnd/>
              <a:tailEnd/>
            </a:ln>
          </p:spPr>
          <p:txBody>
            <a:bodyPr vert="eaVert" anchor="ctr"/>
            <a:lstStyle/>
            <a:p>
              <a:pPr algn="ctr">
                <a:defRPr/>
              </a:pPr>
              <a:endParaRPr lang="en-US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E61A4E0-8037-45E6-A3C8-0B752C39CE6C}"/>
                </a:ext>
              </a:extLst>
            </p:cNvPr>
            <p:cNvSpPr txBox="1"/>
            <p:nvPr/>
          </p:nvSpPr>
          <p:spPr>
            <a:xfrm>
              <a:off x="7854628" y="2474969"/>
              <a:ext cx="2935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-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4E2C79B4-C3E2-46F5-9D80-B4CEF05D6C2C}"/>
                </a:ext>
              </a:extLst>
            </p:cNvPr>
            <p:cNvSpPr txBox="1"/>
            <p:nvPr/>
          </p:nvSpPr>
          <p:spPr>
            <a:xfrm>
              <a:off x="6272085" y="390175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137C7A0E-79AB-4062-ACA0-F33D312AAD7F}"/>
                </a:ext>
              </a:extLst>
            </p:cNvPr>
            <p:cNvSpPr txBox="1"/>
            <p:nvPr/>
          </p:nvSpPr>
          <p:spPr>
            <a:xfrm>
              <a:off x="6275068" y="427430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286FC7EF-8BA0-4084-A897-182EFFA04268}"/>
                </a:ext>
              </a:extLst>
            </p:cNvPr>
            <p:cNvSpPr txBox="1"/>
            <p:nvPr/>
          </p:nvSpPr>
          <p:spPr>
            <a:xfrm>
              <a:off x="6272085" y="477027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7EF0276E-98B7-4CA2-AFFC-DA638974C899}"/>
                </a:ext>
              </a:extLst>
            </p:cNvPr>
            <p:cNvSpPr txBox="1"/>
            <p:nvPr/>
          </p:nvSpPr>
          <p:spPr>
            <a:xfrm>
              <a:off x="6234337" y="511540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D46AD9C4-A1E7-4531-806E-0CA8139BBCFD}"/>
                </a:ext>
              </a:extLst>
            </p:cNvPr>
            <p:cNvSpPr txBox="1"/>
            <p:nvPr/>
          </p:nvSpPr>
          <p:spPr>
            <a:xfrm>
              <a:off x="6177733" y="3569337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7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707313B4-4DDE-44BA-92C3-16156B11971D}"/>
                </a:ext>
              </a:extLst>
            </p:cNvPr>
            <p:cNvSpPr txBox="1"/>
            <p:nvPr/>
          </p:nvSpPr>
          <p:spPr>
            <a:xfrm>
              <a:off x="6161692" y="3278075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  10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8A2D7F2C-36B1-428B-9FD0-6EF166EC00BF}"/>
                </a:ext>
              </a:extLst>
            </p:cNvPr>
            <p:cNvSpPr txBox="1"/>
            <p:nvPr/>
          </p:nvSpPr>
          <p:spPr>
            <a:xfrm>
              <a:off x="6147436" y="2371703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82E40709-C7F4-4B36-9808-B01368304188}"/>
                </a:ext>
              </a:extLst>
            </p:cNvPr>
            <p:cNvSpPr txBox="1"/>
            <p:nvPr/>
          </p:nvSpPr>
          <p:spPr>
            <a:xfrm>
              <a:off x="8218352" y="3595887"/>
              <a:ext cx="45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YlrC</a:t>
              </a:r>
              <a:endParaRPr lang="en-US" sz="1200" dirty="0"/>
            </a:p>
          </p:txBody>
        </p:sp>
        <p:sp>
          <p:nvSpPr>
            <p:cNvPr id="83" name="Isosceles Triangle 82">
              <a:extLst>
                <a:ext uri="{FF2B5EF4-FFF2-40B4-BE49-F238E27FC236}">
                  <a16:creationId xmlns:a16="http://schemas.microsoft.com/office/drawing/2014/main" xmlns="" id="{8B3B8455-8A5A-4DE6-80FC-EA1523DF4DE6}"/>
                </a:ext>
              </a:extLst>
            </p:cNvPr>
            <p:cNvSpPr/>
            <p:nvPr/>
          </p:nvSpPr>
          <p:spPr>
            <a:xfrm rot="16200000" flipH="1">
              <a:off x="8167230" y="3686429"/>
              <a:ext cx="109711" cy="9983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618187" y="425002"/>
            <a:ext cx="30909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4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365938" y="5160388"/>
            <a:ext cx="3494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ernatant                             Pellet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697337" y="5546869"/>
            <a:ext cx="892871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 Expression and secretion of FLAG-tagged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C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(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3S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(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D</a:t>
            </a:r>
            <a:r>
              <a:rPr lang="en-US" sz="14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ndicated strains possessing a FLAG-tagge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ncoding plasmid were propagated either in 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ce (+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absenc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 of 2.5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lcium for 5 hr at 37 °C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ion, but not expression, of T3SS substrates occurs in the absence of calcium.) Culture supernatants and bacterial cells were collected and analyzed by western blotting using an anti-FLAG antibody. </a:t>
            </a:r>
          </a:p>
        </p:txBody>
      </p:sp>
    </p:spTree>
    <p:extLst>
      <p:ext uri="{BB962C8B-B14F-4D97-AF65-F5344CB8AC3E}">
        <p14:creationId xmlns:p14="http://schemas.microsoft.com/office/powerpoint/2010/main" val="10781342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Ylrs 1 - 8 bits 1 - 16 bits 1.tif">
            <a:extLst>
              <a:ext uri="{FF2B5EF4-FFF2-40B4-BE49-F238E27FC236}">
                <a16:creationId xmlns:a16="http://schemas.microsoft.com/office/drawing/2014/main" xmlns="" id="{7793B126-081C-4972-9E2F-B8ADBA0CFB9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76" t="14609" r="41016" b="37412"/>
          <a:stretch/>
        </p:blipFill>
        <p:spPr bwMode="auto">
          <a:xfrm>
            <a:off x="5783173" y="2745354"/>
            <a:ext cx="1629171" cy="20907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E:\Ylrs 1 - 8 bits 1 - 16 bits 1.tif">
            <a:extLst>
              <a:ext uri="{FF2B5EF4-FFF2-40B4-BE49-F238E27FC236}">
                <a16:creationId xmlns:a16="http://schemas.microsoft.com/office/drawing/2014/main" xmlns="" id="{E079F1B9-44B9-4114-81D3-1234E602E32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1" t="14609" r="80134" b="37412"/>
          <a:stretch/>
        </p:blipFill>
        <p:spPr bwMode="auto">
          <a:xfrm>
            <a:off x="4979915" y="2745354"/>
            <a:ext cx="671732" cy="20907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711D3AE-F075-4256-B3C4-E43DDB4698F7}"/>
              </a:ext>
            </a:extLst>
          </p:cNvPr>
          <p:cNvSpPr txBox="1"/>
          <p:nvPr/>
        </p:nvSpPr>
        <p:spPr>
          <a:xfrm>
            <a:off x="4668309" y="290361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3DA613F-71F9-4287-8801-C482D091BFF0}"/>
              </a:ext>
            </a:extLst>
          </p:cNvPr>
          <p:cNvSpPr txBox="1"/>
          <p:nvPr/>
        </p:nvSpPr>
        <p:spPr>
          <a:xfrm>
            <a:off x="4734033" y="336081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5D9ED96-99D4-45F1-B5C7-C6C1C8E79EF6}"/>
              </a:ext>
            </a:extLst>
          </p:cNvPr>
          <p:cNvSpPr txBox="1"/>
          <p:nvPr/>
        </p:nvSpPr>
        <p:spPr>
          <a:xfrm>
            <a:off x="4734033" y="372419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AB6047D-D476-47E6-9C35-CEB3DBD80C18}"/>
              </a:ext>
            </a:extLst>
          </p:cNvPr>
          <p:cNvSpPr txBox="1"/>
          <p:nvPr/>
        </p:nvSpPr>
        <p:spPr>
          <a:xfrm>
            <a:off x="4734033" y="397041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56505F04-C78F-49E1-A987-76EA2F483930}"/>
              </a:ext>
            </a:extLst>
          </p:cNvPr>
          <p:cNvSpPr txBox="1"/>
          <p:nvPr/>
        </p:nvSpPr>
        <p:spPr>
          <a:xfrm>
            <a:off x="4734033" y="433379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E48C0DB-2A02-4D2E-A4C3-312C6E80DA11}"/>
              </a:ext>
            </a:extLst>
          </p:cNvPr>
          <p:cNvSpPr txBox="1"/>
          <p:nvPr/>
        </p:nvSpPr>
        <p:spPr>
          <a:xfrm>
            <a:off x="4640174" y="2657395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198759E-C680-4957-8CF7-6239D6D0F548}"/>
              </a:ext>
            </a:extLst>
          </p:cNvPr>
          <p:cNvSpPr txBox="1"/>
          <p:nvPr/>
        </p:nvSpPr>
        <p:spPr>
          <a:xfrm rot="16200000">
            <a:off x="4706205" y="2207798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 ST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866F3A2-7D83-4765-96CC-1EFEEA6B0DA7}"/>
              </a:ext>
            </a:extLst>
          </p:cNvPr>
          <p:cNvSpPr txBox="1"/>
          <p:nvPr/>
        </p:nvSpPr>
        <p:spPr>
          <a:xfrm rot="16200000">
            <a:off x="5152153" y="2288498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DBDFF01E-85AA-4F1D-BCB3-71529D2A704A}"/>
              </a:ext>
            </a:extLst>
          </p:cNvPr>
          <p:cNvSpPr txBox="1"/>
          <p:nvPr/>
        </p:nvSpPr>
        <p:spPr>
          <a:xfrm>
            <a:off x="5771119" y="24991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6FDDF7A-A433-4323-9ABD-88419A6E2DAA}"/>
              </a:ext>
            </a:extLst>
          </p:cNvPr>
          <p:cNvSpPr txBox="1"/>
          <p:nvPr/>
        </p:nvSpPr>
        <p:spPr>
          <a:xfrm>
            <a:off x="6017306" y="250118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15A23B7-F0F6-4411-A86C-B06ADC00F191}"/>
              </a:ext>
            </a:extLst>
          </p:cNvPr>
          <p:cNvSpPr txBox="1"/>
          <p:nvPr/>
        </p:nvSpPr>
        <p:spPr>
          <a:xfrm>
            <a:off x="6314589" y="25015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7979E636-34FD-4E42-9537-352A44D2F280}"/>
              </a:ext>
            </a:extLst>
          </p:cNvPr>
          <p:cNvSpPr txBox="1"/>
          <p:nvPr/>
        </p:nvSpPr>
        <p:spPr>
          <a:xfrm>
            <a:off x="6560776" y="25035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118A0856-F54C-4DA1-A8E2-0E7CDD7CC76A}"/>
              </a:ext>
            </a:extLst>
          </p:cNvPr>
          <p:cNvSpPr txBox="1"/>
          <p:nvPr/>
        </p:nvSpPr>
        <p:spPr>
          <a:xfrm>
            <a:off x="6858059" y="25038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511FF76-7235-47CD-8FB3-27381410E164}"/>
              </a:ext>
            </a:extLst>
          </p:cNvPr>
          <p:cNvSpPr txBox="1"/>
          <p:nvPr/>
        </p:nvSpPr>
        <p:spPr>
          <a:xfrm>
            <a:off x="7104246" y="250594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A9D9BCF7-542D-47E1-9932-6FC4F7D013A6}"/>
              </a:ext>
            </a:extLst>
          </p:cNvPr>
          <p:cNvSpPr txBox="1"/>
          <p:nvPr/>
        </p:nvSpPr>
        <p:spPr>
          <a:xfrm rot="17677196">
            <a:off x="5724046" y="1949790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YlrB-Bl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E2E9CA0E-DA12-48A6-920B-B6ECE3F94D91}"/>
              </a:ext>
            </a:extLst>
          </p:cNvPr>
          <p:cNvSpPr txBox="1"/>
          <p:nvPr/>
        </p:nvSpPr>
        <p:spPr>
          <a:xfrm rot="17729882">
            <a:off x="6261146" y="1930740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YlrA-Bl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1B626805-EDB1-470E-A95C-F0E8D1400C6D}"/>
              </a:ext>
            </a:extLst>
          </p:cNvPr>
          <p:cNvSpPr txBox="1"/>
          <p:nvPr/>
        </p:nvSpPr>
        <p:spPr>
          <a:xfrm rot="17653976">
            <a:off x="6799289" y="1926732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YlrC-Bl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Isosceles Triangle 29">
            <a:extLst>
              <a:ext uri="{FF2B5EF4-FFF2-40B4-BE49-F238E27FC236}">
                <a16:creationId xmlns:a16="http://schemas.microsoft.com/office/drawing/2014/main" xmlns="" id="{29C505EE-D1B4-4568-85BF-F440BF5B582C}"/>
              </a:ext>
            </a:extLst>
          </p:cNvPr>
          <p:cNvSpPr/>
          <p:nvPr/>
        </p:nvSpPr>
        <p:spPr>
          <a:xfrm rot="5400000">
            <a:off x="5706974" y="3607037"/>
            <a:ext cx="76200" cy="762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Isosceles Triangle 30">
            <a:extLst>
              <a:ext uri="{FF2B5EF4-FFF2-40B4-BE49-F238E27FC236}">
                <a16:creationId xmlns:a16="http://schemas.microsoft.com/office/drawing/2014/main" xmlns="" id="{51BA4964-D19D-4A2B-9B9A-70D20C3631CD}"/>
              </a:ext>
            </a:extLst>
          </p:cNvPr>
          <p:cNvSpPr/>
          <p:nvPr/>
        </p:nvSpPr>
        <p:spPr>
          <a:xfrm rot="16200000">
            <a:off x="7412345" y="3161743"/>
            <a:ext cx="76200" cy="762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ight Brace 29">
            <a:extLst>
              <a:ext uri="{FF2B5EF4-FFF2-40B4-BE49-F238E27FC236}">
                <a16:creationId xmlns:a16="http://schemas.microsoft.com/office/drawing/2014/main" xmlns="" id="{EBCDAFF7-9F58-4CCF-9461-06F0AADFEE3C}"/>
              </a:ext>
            </a:extLst>
          </p:cNvPr>
          <p:cNvSpPr>
            <a:spLocks/>
          </p:cNvSpPr>
          <p:nvPr/>
        </p:nvSpPr>
        <p:spPr bwMode="auto">
          <a:xfrm rot="16200000">
            <a:off x="6005850" y="2298432"/>
            <a:ext cx="45719" cy="427635"/>
          </a:xfrm>
          <a:prstGeom prst="rightBrace">
            <a:avLst>
              <a:gd name="adj1" fmla="val 36282"/>
              <a:gd name="adj2" fmla="val 50000"/>
            </a:avLst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  <p:txBody>
          <a:bodyPr vert="eaVert" anchor="ctr"/>
          <a:lstStyle/>
          <a:p>
            <a:pPr algn="ctr">
              <a:defRPr/>
            </a:pPr>
            <a:endParaRPr lang="en-US">
              <a:solidFill>
                <a:srgbClr val="000000"/>
              </a:solidFill>
              <a:latin typeface="+mn-lt"/>
            </a:endParaRPr>
          </a:p>
        </p:txBody>
      </p:sp>
      <p:sp>
        <p:nvSpPr>
          <p:cNvPr id="33" name="Right Brace 29">
            <a:extLst>
              <a:ext uri="{FF2B5EF4-FFF2-40B4-BE49-F238E27FC236}">
                <a16:creationId xmlns:a16="http://schemas.microsoft.com/office/drawing/2014/main" xmlns="" id="{C275C1DB-E724-497D-8F1A-93F00BB0560F}"/>
              </a:ext>
            </a:extLst>
          </p:cNvPr>
          <p:cNvSpPr>
            <a:spLocks/>
          </p:cNvSpPr>
          <p:nvPr/>
        </p:nvSpPr>
        <p:spPr bwMode="auto">
          <a:xfrm rot="16200000">
            <a:off x="7095205" y="2291944"/>
            <a:ext cx="45719" cy="427635"/>
          </a:xfrm>
          <a:prstGeom prst="rightBrace">
            <a:avLst>
              <a:gd name="adj1" fmla="val 36282"/>
              <a:gd name="adj2" fmla="val 50000"/>
            </a:avLst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  <p:txBody>
          <a:bodyPr vert="eaVert" anchor="ctr"/>
          <a:lstStyle/>
          <a:p>
            <a:pPr algn="ctr">
              <a:defRPr/>
            </a:pPr>
            <a:endParaRPr lang="en-US">
              <a:solidFill>
                <a:srgbClr val="000000"/>
              </a:solidFill>
              <a:latin typeface="+mn-lt"/>
            </a:endParaRPr>
          </a:p>
        </p:txBody>
      </p:sp>
      <p:sp>
        <p:nvSpPr>
          <p:cNvPr id="34" name="Right Brace 29">
            <a:extLst>
              <a:ext uri="{FF2B5EF4-FFF2-40B4-BE49-F238E27FC236}">
                <a16:creationId xmlns:a16="http://schemas.microsoft.com/office/drawing/2014/main" xmlns="" id="{D51F6922-D02A-4222-BE2F-D64F19709887}"/>
              </a:ext>
            </a:extLst>
          </p:cNvPr>
          <p:cNvSpPr>
            <a:spLocks/>
          </p:cNvSpPr>
          <p:nvPr/>
        </p:nvSpPr>
        <p:spPr bwMode="auto">
          <a:xfrm rot="16200000">
            <a:off x="6536031" y="2292129"/>
            <a:ext cx="45719" cy="427635"/>
          </a:xfrm>
          <a:prstGeom prst="rightBrace">
            <a:avLst>
              <a:gd name="adj1" fmla="val 36282"/>
              <a:gd name="adj2" fmla="val 50000"/>
            </a:avLst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  <p:txBody>
          <a:bodyPr vert="eaVert" anchor="ctr"/>
          <a:lstStyle/>
          <a:p>
            <a:pPr algn="ctr">
              <a:defRPr/>
            </a:pPr>
            <a:endParaRPr lang="en-US">
              <a:solidFill>
                <a:srgbClr val="000000"/>
              </a:solidFill>
              <a:latin typeface="+mn-lt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8187" y="425002"/>
            <a:ext cx="30909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515312" y="5046327"/>
            <a:ext cx="576677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 Expression levels of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B-Bla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A-Bla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lrC-Bla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replicates (a and b) of w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l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ysates of strains possessing the indicated expression plasmids were collected and analyzed by western blotting using an anti-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hown to the left is a whole cell lysate from a non-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formed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. pesti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milarily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zed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8592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</TotalTime>
  <Words>609</Words>
  <Application>Microsoft Office PowerPoint</Application>
  <PresentationFormat>Widescreen</PresentationFormat>
  <Paragraphs>122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esser Bartra, Sara C</dc:creator>
  <cp:lastModifiedBy>Schesser, Kurt R</cp:lastModifiedBy>
  <cp:revision>32</cp:revision>
  <cp:lastPrinted>2018-12-18T19:30:21Z</cp:lastPrinted>
  <dcterms:created xsi:type="dcterms:W3CDTF">2018-12-05T22:22:14Z</dcterms:created>
  <dcterms:modified xsi:type="dcterms:W3CDTF">2018-12-20T15:53:57Z</dcterms:modified>
</cp:coreProperties>
</file>